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79"/>
  </p:normalViewPr>
  <p:slideViewPr>
    <p:cSldViewPr snapToGrid="0" snapToObjects="1">
      <p:cViewPr varScale="1">
        <p:scale>
          <a:sx n="115" d="100"/>
          <a:sy n="115" d="100"/>
        </p:scale>
        <p:origin x="3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39752-DB4A-5647-9EB2-C8BEFEF948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4D778C-603D-1E46-9F62-62D51B5939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F623D1-B11C-A64D-A3D4-0A97AE14D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017064-B4A9-5C48-B048-EE7F20420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117BF7-F6C1-A64B-9B26-306ED9799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11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38620-393A-2841-B621-087CDDDB29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A9DF50-4C94-1A4D-97AD-22C0615E7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693925-2EB5-E04C-B93D-846F76000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9A694D-475E-AC43-A53E-416B41C19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19633-084C-8744-814B-E31570E33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313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346E6D-84C7-6945-AFCC-BC3B5AF9F1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176B61-36C7-9149-9A2C-B97726CA24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5704C1-5E67-3A45-8BBF-7F85C086F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33A80A-6FBE-4F4C-9DDE-DE524771D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E12B4-DC46-9946-B825-DAB6C9472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756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69EA7-C9BD-5242-B08E-AC674D396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BDF87A-9473-A54C-8299-0795C94D87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7D521E-B1FD-2D4B-B49F-24A94ACCC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BD9C0-6876-764A-B0DB-364D1D905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DB3DBF-8C43-0942-8627-46F43AA00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48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AA0D0-7472-D543-A30F-73172DC74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1C9ECC-739F-8144-967F-2F2ABCB9FB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42FFFA-BBA1-0B48-9F86-BF1254A3D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3ECE4D-22F5-E249-B198-8A32F3A8C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F39CCC-6354-C645-9C9C-9675462E8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211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89A19-612C-DF49-AFA3-FD78256A5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CBA6A1-772B-2F40-B642-CF9271C1B1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B932B2-E52F-9F44-82D1-A970E4CD91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745996-F2D3-5C47-868D-B867D64B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E323A6-B648-2A4F-972D-B52309806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0428B2-95F6-FA45-BABF-9473E99F7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520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FF0E2-91C9-BB46-86D5-A82BE3D70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B88DE8-7521-A646-8C48-87428A314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591627-54F7-D14C-B09D-4179A12DCF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4D1321-6845-124E-8B7F-EC62D051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4557EF-9E65-DB4C-A0A9-DF9CF163CD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CC23E1-D39D-A647-9641-4080FA920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AC5B08-2677-074E-B250-556B1625E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96007D-E7A7-5D4F-8E85-D4902AB9F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404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E6A2E-C4FD-6A45-AB2D-F43FD9F87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744AC2-8FAF-D947-83FA-F21BC79DD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30EB0F-5BC7-0A4D-8809-3C5CF9F18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DB0D81-55BD-574D-A514-8EE47ABBB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657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86DD6B-1E69-0E4B-AF71-A76563F59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20B30F-050F-594A-841B-3376FB726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B22DAB-0AEE-1246-9A1D-D70C26593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05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721DE-A9F4-0040-B1D6-BC5FBBB279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D238C7-B515-174B-B73C-A9D7FDF21E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D28885-E4F2-E044-809C-F43A9B03C4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93A454-D6C8-5249-8420-6B9D00292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7E8BBF-99B2-7444-B3E8-27009A351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7E70D3-D937-4742-B237-9F02A3047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01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35E3A6-5C39-8248-B95D-8C62364FE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DBA1E2-6E46-494E-9ECF-C59E09E204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692142-1EE0-E84C-88B7-4A47F6CABF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A303A-EE54-7645-8CE6-06D115DB5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957D70-7D59-9C47-A9B1-D6A228ECE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7B299E-05D2-0F4C-9A7D-72FB007EE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024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603715-605A-804D-AA20-81C240E79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63A30E-86CC-B64A-9AB8-7AF36E31FF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D781C9-1826-4443-8220-F06A3FAD7B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8E387-5D94-1F4E-BD68-9117CA415501}" type="datetimeFigureOut">
              <a:rPr lang="en-US" smtClean="0"/>
              <a:t>11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86706E-CF75-8B4D-B101-59C8309024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B6C691-3E8A-704C-BEBF-95EE72D902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84B44-B0A6-EB41-A1CE-7256CF4F3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62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3" name="Image" descr="Imag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0000" y="1835150"/>
            <a:ext cx="5410200" cy="3187700"/>
          </a:xfrm>
          <a:prstGeom prst="rect">
            <a:avLst/>
          </a:prstGeom>
          <a:ln w="12700">
            <a:miter lim="400000"/>
          </a:ln>
        </p:spPr>
      </p:pic>
      <p:sp>
        <p:nvSpPr>
          <p:cNvPr id="474" name="Rectangle"/>
          <p:cNvSpPr/>
          <p:nvPr/>
        </p:nvSpPr>
        <p:spPr>
          <a:xfrm>
            <a:off x="5891162" y="4029670"/>
            <a:ext cx="312044" cy="349945"/>
          </a:xfrm>
          <a:prstGeom prst="rect">
            <a:avLst/>
          </a:prstGeom>
          <a:gradFill>
            <a:gsLst>
              <a:gs pos="0">
                <a:schemeClr val="accent4">
                  <a:hueOff val="-406799"/>
                  <a:lumOff val="30382"/>
                </a:schemeClr>
              </a:gs>
              <a:gs pos="50000">
                <a:srgbClr val="FFD58D"/>
              </a:gs>
              <a:gs pos="100000">
                <a:schemeClr val="accent4">
                  <a:hueOff val="-362075"/>
                  <a:lumOff val="23565"/>
                </a:schemeClr>
              </a:gs>
            </a:gsLst>
            <a:lin ang="5400000"/>
          </a:gradFill>
          <a:ln w="12700">
            <a:solidFill>
              <a:schemeClr val="accent4"/>
            </a:solidFill>
            <a:miter/>
          </a:ln>
        </p:spPr>
        <p:txBody>
          <a:bodyPr lIns="45719" rIns="45719" anchor="ctr"/>
          <a:lstStyle/>
          <a:p>
            <a:endParaRPr/>
          </a:p>
        </p:txBody>
      </p:sp>
      <p:sp>
        <p:nvSpPr>
          <p:cNvPr id="475" name="Rectangle"/>
          <p:cNvSpPr/>
          <p:nvPr/>
        </p:nvSpPr>
        <p:spPr>
          <a:xfrm>
            <a:off x="5300017" y="4243486"/>
            <a:ext cx="217389" cy="133302"/>
          </a:xfrm>
          <a:prstGeom prst="rect">
            <a:avLst/>
          </a:prstGeom>
          <a:gradFill>
            <a:gsLst>
              <a:gs pos="0">
                <a:schemeClr val="accent4">
                  <a:hueOff val="-406799"/>
                  <a:lumOff val="30382"/>
                </a:schemeClr>
              </a:gs>
              <a:gs pos="50000">
                <a:srgbClr val="FFD58D"/>
              </a:gs>
              <a:gs pos="100000">
                <a:schemeClr val="accent4">
                  <a:hueOff val="-362075"/>
                  <a:lumOff val="23565"/>
                </a:schemeClr>
              </a:gs>
            </a:gsLst>
            <a:lin ang="5400000"/>
          </a:gradFill>
          <a:ln w="6350">
            <a:solidFill>
              <a:schemeClr val="accent4"/>
            </a:solidFill>
            <a:miter/>
          </a:ln>
        </p:spPr>
        <p:txBody>
          <a:bodyPr lIns="45719" rIns="45719" anchor="ctr"/>
          <a:lstStyle/>
          <a:p>
            <a:endParaRPr/>
          </a:p>
        </p:txBody>
      </p:sp>
      <p:sp>
        <p:nvSpPr>
          <p:cNvPr id="477" name="Square"/>
          <p:cNvSpPr/>
          <p:nvPr/>
        </p:nvSpPr>
        <p:spPr>
          <a:xfrm>
            <a:off x="5004345" y="5118844"/>
            <a:ext cx="121197" cy="133301"/>
          </a:xfrm>
          <a:prstGeom prst="rect">
            <a:avLst/>
          </a:prstGeom>
          <a:gradFill>
            <a:gsLst>
              <a:gs pos="0">
                <a:schemeClr val="accent4">
                  <a:hueOff val="-406799"/>
                  <a:lumOff val="30382"/>
                </a:schemeClr>
              </a:gs>
              <a:gs pos="50000">
                <a:srgbClr val="FFD58D"/>
              </a:gs>
              <a:gs pos="100000">
                <a:schemeClr val="accent4">
                  <a:hueOff val="-362075"/>
                  <a:lumOff val="23565"/>
                </a:schemeClr>
              </a:gs>
            </a:gsLst>
            <a:lin ang="5400000"/>
          </a:gradFill>
          <a:ln w="6350">
            <a:solidFill>
              <a:schemeClr val="accent4"/>
            </a:solidFill>
            <a:miter/>
          </a:ln>
        </p:spPr>
        <p:txBody>
          <a:bodyPr lIns="45719" rIns="45719" anchor="ctr"/>
          <a:lstStyle/>
          <a:p>
            <a:endParaRPr/>
          </a:p>
        </p:txBody>
      </p:sp>
      <p:sp>
        <p:nvSpPr>
          <p:cNvPr id="478" name="Changing fold change direction from T1 to T3"/>
          <p:cNvSpPr txBox="1"/>
          <p:nvPr/>
        </p:nvSpPr>
        <p:spPr>
          <a:xfrm>
            <a:off x="5141082" y="5044524"/>
            <a:ext cx="3463539" cy="2819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300">
                <a:solidFill>
                  <a:srgbClr val="535353"/>
                </a:solidFill>
              </a:defRPr>
            </a:lvl1pPr>
          </a:lstStyle>
          <a:p>
            <a:r>
              <a:t>Changing fold change direction from T1 to T3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8C7E030-449B-6D49-9D3E-0B525DF690BB}"/>
              </a:ext>
            </a:extLst>
          </p:cNvPr>
          <p:cNvSpPr/>
          <p:nvPr/>
        </p:nvSpPr>
        <p:spPr>
          <a:xfrm>
            <a:off x="1106905" y="5913804"/>
            <a:ext cx="998621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1 The number of hyper- and hypo-methylated genes before and after treatmen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7650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oting Yang</dc:creator>
  <cp:lastModifiedBy>Ruoting Yang</cp:lastModifiedBy>
  <cp:revision>1</cp:revision>
  <dcterms:created xsi:type="dcterms:W3CDTF">2020-11-17T21:36:37Z</dcterms:created>
  <dcterms:modified xsi:type="dcterms:W3CDTF">2020-11-17T21:37:38Z</dcterms:modified>
</cp:coreProperties>
</file>